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703090-8AFE-4FEB-B760-9C62FB2C3C5E}" type="datetime">
              <a:rPr b="0" lang="en-US" sz="1200" spc="-1" strike="noStrike">
                <a:solidFill>
                  <a:srgbClr val="000000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2CE398-903C-4211-823A-1D19CF12AE4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3A6B76-0448-403A-A03F-EC3980635D8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71510B-D311-445F-B068-E7B8AB5492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77E223-C06A-49AF-91D3-3658059087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CDAA0D-EBD9-4CD4-AF3A-CAE98968B9F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2630D6-BEAC-4BDD-9DC1-33DA7CEFD61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2D9DE0-7BB0-4A52-AA89-241391EF5B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27D217-CCBE-4320-ADFE-A54BF79CE1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02F3AA-C7E7-47A9-880D-A2ED9E4E52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C80BE7-F017-4D56-A2BA-73DF39C464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ACD96D-495B-4CCB-AFED-A6C6268EC0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28CDD8-B700-4342-A121-445F4D6901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CB60BA-D501-44BB-A880-3A1E1F06E1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21E3D6-F7A4-4960-B789-A846C14433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3059E9A-4D7E-4FB1-B573-AC9FACA7CB48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95ACE9-6FE4-4041-81B4-8175B2522C2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rcRect l="27134" t="29412" r="31555" b="17647"/>
          <a:stretch/>
        </p:blipFill>
        <p:spPr>
          <a:xfrm>
            <a:off x="1676520" y="1077840"/>
            <a:ext cx="4833720" cy="4114800"/>
          </a:xfrm>
          <a:prstGeom prst="rect">
            <a:avLst/>
          </a:prstGeom>
          <a:ln w="0">
            <a:noFill/>
          </a:ln>
        </p:spPr>
      </p:pic>
      <p:sp>
        <p:nvSpPr>
          <p:cNvPr id="49" name="TextBox 7"/>
          <p:cNvSpPr/>
          <p:nvPr/>
        </p:nvSpPr>
        <p:spPr>
          <a:xfrm>
            <a:off x="2192040" y="5481720"/>
            <a:ext cx="172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0 or 1 risk alle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8"/>
          <p:cNvSpPr/>
          <p:nvPr/>
        </p:nvSpPr>
        <p:spPr>
          <a:xfrm>
            <a:off x="4641480" y="5521320"/>
            <a:ext cx="1308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 risk alle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0"/>
          <p:cNvSpPr/>
          <p:nvPr/>
        </p:nvSpPr>
        <p:spPr>
          <a:xfrm>
            <a:off x="3682080" y="610704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s37885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2"/>
          <p:cNvSpPr/>
          <p:nvPr/>
        </p:nvSpPr>
        <p:spPr>
          <a:xfrm>
            <a:off x="6629400" y="1143000"/>
            <a:ext cx="2309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_interaction =0.02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or rs378854 * STATU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7"/>
          <p:cNvSpPr/>
          <p:nvPr/>
        </p:nvSpPr>
        <p:spPr>
          <a:xfrm rot="19008000">
            <a:off x="2242080" y="453240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orm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8"/>
          <p:cNvSpPr/>
          <p:nvPr/>
        </p:nvSpPr>
        <p:spPr>
          <a:xfrm rot="19008000">
            <a:off x="3170880" y="449280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umo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9"/>
          <p:cNvSpPr/>
          <p:nvPr/>
        </p:nvSpPr>
        <p:spPr>
          <a:xfrm rot="19008000">
            <a:off x="4464360" y="445608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orm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0"/>
          <p:cNvSpPr/>
          <p:nvPr/>
        </p:nvSpPr>
        <p:spPr>
          <a:xfrm rot="19008000">
            <a:off x="5761800" y="449280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umo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1"/>
          <p:cNvSpPr/>
          <p:nvPr/>
        </p:nvSpPr>
        <p:spPr>
          <a:xfrm>
            <a:off x="2253960" y="5140440"/>
            <a:ext cx="64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n=2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2"/>
          <p:cNvSpPr/>
          <p:nvPr/>
        </p:nvSpPr>
        <p:spPr>
          <a:xfrm>
            <a:off x="3121200" y="5151600"/>
            <a:ext cx="64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n=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13"/>
          <p:cNvSpPr/>
          <p:nvPr/>
        </p:nvSpPr>
        <p:spPr>
          <a:xfrm>
            <a:off x="4507920" y="5157720"/>
            <a:ext cx="64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n=3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14"/>
          <p:cNvSpPr/>
          <p:nvPr/>
        </p:nvSpPr>
        <p:spPr>
          <a:xfrm>
            <a:off x="5505480" y="5140440"/>
            <a:ext cx="531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n=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15"/>
          <p:cNvSpPr/>
          <p:nvPr/>
        </p:nvSpPr>
        <p:spPr>
          <a:xfrm rot="16200000">
            <a:off x="-1066320" y="2858040"/>
            <a:ext cx="4604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ormalized mir-1208 expression, log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an values with 95% confidence interval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eft Bracket 16"/>
          <p:cNvSpPr/>
          <p:nvPr/>
        </p:nvSpPr>
        <p:spPr>
          <a:xfrm rot="5400000">
            <a:off x="3771720" y="125280"/>
            <a:ext cx="152280" cy="2362320"/>
          </a:xfrm>
          <a:custGeom>
            <a:avLst/>
            <a:gdLst>
              <a:gd name="textAreaLeft" fmla="*/ 44640 w 152280"/>
              <a:gd name="textAreaRight" fmla="*/ 152640 w 152280"/>
              <a:gd name="textAreaTop" fmla="*/ 6120 h 2362320"/>
              <a:gd name="textAreaBottom" fmla="*/ 2356200 h 23623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58"/>
                  <a:pt x="0" y="116"/>
                </a:cubicBezTo>
                <a:lnTo>
                  <a:pt x="0" y="21484"/>
                </a:lnTo>
                <a:cubicBezTo>
                  <a:pt x="0" y="21542"/>
                  <a:pt x="10800" y="21600"/>
                  <a:pt x="2160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eft Bracket 17"/>
          <p:cNvSpPr/>
          <p:nvPr/>
        </p:nvSpPr>
        <p:spPr>
          <a:xfrm rot="5400000">
            <a:off x="4686120" y="429840"/>
            <a:ext cx="228600" cy="2438640"/>
          </a:xfrm>
          <a:custGeom>
            <a:avLst/>
            <a:gdLst>
              <a:gd name="textAreaLeft" fmla="*/ 66960 w 228600"/>
              <a:gd name="textAreaRight" fmla="*/ 228960 w 228600"/>
              <a:gd name="textAreaTop" fmla="*/ 9360 h 2438640"/>
              <a:gd name="textAreaBottom" fmla="*/ 2429280 h 2438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85"/>
                  <a:pt x="0" y="169"/>
                </a:cubicBezTo>
                <a:lnTo>
                  <a:pt x="0" y="21431"/>
                </a:lnTo>
                <a:cubicBezTo>
                  <a:pt x="0" y="21516"/>
                  <a:pt x="10800" y="21600"/>
                  <a:pt x="21600" y="21600"/>
                </a:cubicBezTo>
              </a:path>
            </a:pathLst>
          </a:cu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18"/>
          <p:cNvSpPr/>
          <p:nvPr/>
        </p:nvSpPr>
        <p:spPr>
          <a:xfrm>
            <a:off x="3299400" y="609480"/>
            <a:ext cx="103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=0.04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19"/>
          <p:cNvSpPr/>
          <p:nvPr/>
        </p:nvSpPr>
        <p:spPr>
          <a:xfrm>
            <a:off x="5051880" y="1219320"/>
            <a:ext cx="103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=0.06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19"/>
          <p:cNvSpPr/>
          <p:nvPr/>
        </p:nvSpPr>
        <p:spPr>
          <a:xfrm>
            <a:off x="7169040" y="152280"/>
            <a:ext cx="1284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gure S9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1T17:36:00Z</dcterms:created>
  <dc:creator>Mila</dc:creator>
  <dc:description/>
  <dc:language>en-US</dc:language>
  <cp:lastModifiedBy>Cancer Research UK</cp:lastModifiedBy>
  <dcterms:modified xsi:type="dcterms:W3CDTF">2011-06-03T19:54:53Z</dcterms:modified>
  <cp:revision>8</cp:revision>
  <dc:subject/>
  <dc:title>Slide 1</dc:title>
</cp:coreProperties>
</file>